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9" r:id="rId2"/>
    <p:sldId id="287" r:id="rId3"/>
    <p:sldId id="288" r:id="rId4"/>
  </p:sldIdLst>
  <p:sldSz cx="12192000" cy="6858000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84" autoAdjust="0"/>
    <p:restoredTop sz="93883" autoAdjust="0"/>
  </p:normalViewPr>
  <p:slideViewPr>
    <p:cSldViewPr snapToGrid="0">
      <p:cViewPr>
        <p:scale>
          <a:sx n="200" d="100"/>
          <a:sy n="200" d="100"/>
        </p:scale>
        <p:origin x="96" y="-15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428F9F-53A6-46E1-B5A9-082A3352C61B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461E33-BD26-4D1A-BDDE-4139EE9E247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0388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400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5522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8050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4527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37018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1781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3866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9178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1423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9502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6107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16F9A-6E8E-466F-BF1B-816E99C49FCD}" type="datetimeFigureOut">
              <a:rPr lang="en-AU" smtClean="0"/>
              <a:t>1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4E929-61C6-4A54-A9DD-89178AAA81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5087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7.xml"/><Relationship Id="rId6" Type="http://schemas.openxmlformats.org/officeDocument/2006/relationships/package" Target="../embeddings/Microsoft_Word_Document2.docx"/><Relationship Id="rId5" Type="http://schemas.openxmlformats.org/officeDocument/2006/relationships/image" Target="../media/image2.emf"/><Relationship Id="rId4" Type="http://schemas.openxmlformats.org/officeDocument/2006/relationships/package" Target="../embeddings/Microsoft_Word_Document1.docx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117">
            <a:extLst>
              <a:ext uri="{FF2B5EF4-FFF2-40B4-BE49-F238E27FC236}">
                <a16:creationId xmlns:a16="http://schemas.microsoft.com/office/drawing/2014/main" id="{FF3A9A99-F557-4DD6-1E5F-671BA636B546}"/>
              </a:ext>
            </a:extLst>
          </p:cNvPr>
          <p:cNvGrpSpPr/>
          <p:nvPr/>
        </p:nvGrpSpPr>
        <p:grpSpPr>
          <a:xfrm>
            <a:off x="489958" y="980603"/>
            <a:ext cx="6446596" cy="6894858"/>
            <a:chOff x="848725" y="527669"/>
            <a:chExt cx="6142625" cy="6168406"/>
          </a:xfrm>
        </p:grpSpPr>
        <p:graphicFrame>
          <p:nvGraphicFramePr>
            <p:cNvPr id="60" name="Object 59">
              <a:extLst>
                <a:ext uri="{FF2B5EF4-FFF2-40B4-BE49-F238E27FC236}">
                  <a16:creationId xmlns:a16="http://schemas.microsoft.com/office/drawing/2014/main" id="{F4088296-2C01-E386-CDB5-5500D836B15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9454842"/>
                </p:ext>
              </p:extLst>
            </p:nvPr>
          </p:nvGraphicFramePr>
          <p:xfrm>
            <a:off x="866099" y="2186913"/>
            <a:ext cx="3179547" cy="45091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Document" r:id="rId2" imgW="5725970" imgH="8477830" progId="Word.Document.12">
                    <p:embed/>
                  </p:oleObj>
                </mc:Choice>
                <mc:Fallback>
                  <p:oleObj name="Document" r:id="rId2" imgW="5725970" imgH="8477830" progId="Word.Document.12">
                    <p:embed/>
                    <p:pic>
                      <p:nvPicPr>
                        <p:cNvPr id="43" name="Object 42">
                          <a:extLst>
                            <a:ext uri="{FF2B5EF4-FFF2-40B4-BE49-F238E27FC236}">
                              <a16:creationId xmlns:a16="http://schemas.microsoft.com/office/drawing/2014/main" id="{6950027C-ACC4-909D-64A7-9816B5C6BF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66099" y="2186913"/>
                          <a:ext cx="3179547" cy="45091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1" name="Object 60">
              <a:extLst>
                <a:ext uri="{FF2B5EF4-FFF2-40B4-BE49-F238E27FC236}">
                  <a16:creationId xmlns:a16="http://schemas.microsoft.com/office/drawing/2014/main" id="{0FCF4AAB-C3D5-E09B-4154-75F859B906B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1638177"/>
                </p:ext>
              </p:extLst>
            </p:nvPr>
          </p:nvGraphicFramePr>
          <p:xfrm>
            <a:off x="864595" y="527669"/>
            <a:ext cx="3179547" cy="45091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Document" r:id="rId4" imgW="5725970" imgH="8477830" progId="Word.Document.12">
                    <p:embed/>
                  </p:oleObj>
                </mc:Choice>
                <mc:Fallback>
                  <p:oleObj name="Document" r:id="rId4" imgW="5725970" imgH="8477830" progId="Word.Document.12">
                    <p:embed/>
                    <p:pic>
                      <p:nvPicPr>
                        <p:cNvPr id="42" name="Object 41">
                          <a:extLst>
                            <a:ext uri="{FF2B5EF4-FFF2-40B4-BE49-F238E27FC236}">
                              <a16:creationId xmlns:a16="http://schemas.microsoft.com/office/drawing/2014/main" id="{C62D9E47-151F-8581-FD4A-E269B07562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64595" y="527669"/>
                          <a:ext cx="3179547" cy="45091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4ED1FF53-FEE6-1934-2174-B02AB9FEDBFA}"/>
                </a:ext>
              </a:extLst>
            </p:cNvPr>
            <p:cNvGrpSpPr/>
            <p:nvPr/>
          </p:nvGrpSpPr>
          <p:grpSpPr>
            <a:xfrm>
              <a:off x="848725" y="1065959"/>
              <a:ext cx="278468" cy="1814122"/>
              <a:chOff x="702675" y="3866316"/>
              <a:chExt cx="250819" cy="1706557"/>
            </a:xfrm>
          </p:grpSpPr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08878F4A-A13E-6ADA-D0AF-B98942F48028}"/>
                  </a:ext>
                </a:extLst>
              </p:cNvPr>
              <p:cNvSpPr txBox="1"/>
              <p:nvPr/>
            </p:nvSpPr>
            <p:spPr>
              <a:xfrm>
                <a:off x="704030" y="3953292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385F457A-6B26-1C21-ACA7-B6A12F589D94}"/>
                  </a:ext>
                </a:extLst>
              </p:cNvPr>
              <p:cNvSpPr txBox="1"/>
              <p:nvPr/>
            </p:nvSpPr>
            <p:spPr>
              <a:xfrm>
                <a:off x="704030" y="3866316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D3158A0C-1B23-5AB1-7872-623630807B3B}"/>
                  </a:ext>
                </a:extLst>
              </p:cNvPr>
              <p:cNvSpPr txBox="1"/>
              <p:nvPr/>
            </p:nvSpPr>
            <p:spPr>
              <a:xfrm>
                <a:off x="702675" y="4700581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31BF7E82-F455-190E-CB82-7B80F6244A04}"/>
                  </a:ext>
                </a:extLst>
              </p:cNvPr>
              <p:cNvSpPr txBox="1"/>
              <p:nvPr/>
            </p:nvSpPr>
            <p:spPr>
              <a:xfrm>
                <a:off x="704708" y="4504332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457E41A-1D75-A2DE-D611-30F08A87046B}"/>
                  </a:ext>
                </a:extLst>
              </p:cNvPr>
              <p:cNvSpPr txBox="1"/>
              <p:nvPr/>
            </p:nvSpPr>
            <p:spPr>
              <a:xfrm>
                <a:off x="703352" y="4157928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6B66D7B4-2A9D-29F6-04F9-F1BB803EAE17}"/>
                  </a:ext>
                </a:extLst>
              </p:cNvPr>
              <p:cNvSpPr txBox="1"/>
              <p:nvPr/>
            </p:nvSpPr>
            <p:spPr>
              <a:xfrm>
                <a:off x="716730" y="4608148"/>
                <a:ext cx="22474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600" dirty="0"/>
                  <a:t>X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CCC717C8-2ABE-CED0-8CB6-31BE9C5505DC}"/>
                  </a:ext>
                </a:extLst>
              </p:cNvPr>
              <p:cNvSpPr txBox="1"/>
              <p:nvPr/>
            </p:nvSpPr>
            <p:spPr>
              <a:xfrm>
                <a:off x="704030" y="4320055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6502799-B7F4-69D5-CBED-8978232814DD}"/>
                  </a:ext>
                </a:extLst>
              </p:cNvPr>
              <p:cNvSpPr txBox="1"/>
              <p:nvPr/>
            </p:nvSpPr>
            <p:spPr>
              <a:xfrm>
                <a:off x="704030" y="4871809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61BF4E0B-3FBF-FEB4-A2C9-990104BF9D5A}"/>
                  </a:ext>
                </a:extLst>
              </p:cNvPr>
              <p:cNvSpPr txBox="1"/>
              <p:nvPr/>
            </p:nvSpPr>
            <p:spPr>
              <a:xfrm>
                <a:off x="704030" y="4969824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A9FE8BF5-0AEA-1902-4C4E-880B15F3217B}"/>
                  </a:ext>
                </a:extLst>
              </p:cNvPr>
              <p:cNvSpPr txBox="1"/>
              <p:nvPr/>
            </p:nvSpPr>
            <p:spPr>
              <a:xfrm>
                <a:off x="702675" y="4056526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E12CC0D1-BE5B-BB68-C367-713DBEA000B6}"/>
                  </a:ext>
                </a:extLst>
              </p:cNvPr>
              <p:cNvSpPr txBox="1"/>
              <p:nvPr/>
            </p:nvSpPr>
            <p:spPr>
              <a:xfrm>
                <a:off x="704030" y="4781302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9A56D5DB-79D2-FFEB-9164-9B7B7E52C579}"/>
                  </a:ext>
                </a:extLst>
              </p:cNvPr>
              <p:cNvSpPr txBox="1"/>
              <p:nvPr/>
            </p:nvSpPr>
            <p:spPr>
              <a:xfrm>
                <a:off x="704154" y="4415660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*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FBDCF75D-ED06-F6A3-A4CD-33C5FB744F8C}"/>
                  </a:ext>
                </a:extLst>
              </p:cNvPr>
              <p:cNvSpPr txBox="1"/>
              <p:nvPr/>
            </p:nvSpPr>
            <p:spPr>
              <a:xfrm>
                <a:off x="702869" y="5050036"/>
                <a:ext cx="23872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50" dirty="0">
                    <a:solidFill>
                      <a:srgbClr val="C00000"/>
                    </a:solidFill>
                  </a:rPr>
                  <a:t>*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3A0B291-D0D8-F2A2-6208-1A1D14086110}"/>
                  </a:ext>
                </a:extLst>
              </p:cNvPr>
              <p:cNvSpPr txBox="1"/>
              <p:nvPr/>
            </p:nvSpPr>
            <p:spPr>
              <a:xfrm>
                <a:off x="702869" y="5318957"/>
                <a:ext cx="23872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50" dirty="0">
                    <a:solidFill>
                      <a:srgbClr val="C00000"/>
                    </a:solidFill>
                  </a:rPr>
                  <a:t>*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82A007E2-4302-E9A5-4D38-E7606274791F}"/>
                  </a:ext>
                </a:extLst>
              </p:cNvPr>
              <p:cNvSpPr txBox="1"/>
              <p:nvPr/>
            </p:nvSpPr>
            <p:spPr>
              <a:xfrm>
                <a:off x="703804" y="5140543"/>
                <a:ext cx="23872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50" dirty="0">
                    <a:solidFill>
                      <a:srgbClr val="C00000"/>
                    </a:solidFill>
                  </a:rPr>
                  <a:t>*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593F91D8-8078-7069-AE38-23271BA0234C}"/>
                  </a:ext>
                </a:extLst>
              </p:cNvPr>
              <p:cNvSpPr txBox="1"/>
              <p:nvPr/>
            </p:nvSpPr>
            <p:spPr>
              <a:xfrm>
                <a:off x="703804" y="5228585"/>
                <a:ext cx="23872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50" dirty="0">
                    <a:solidFill>
                      <a:srgbClr val="C00000"/>
                    </a:solidFill>
                  </a:rPr>
                  <a:t>*</a:t>
                </a:r>
              </a:p>
            </p:txBody>
          </p:sp>
        </p:grp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33F3BC0A-1069-4303-AC0E-EB9CAD67F680}"/>
                </a:ext>
              </a:extLst>
            </p:cNvPr>
            <p:cNvGrpSpPr/>
            <p:nvPr/>
          </p:nvGrpSpPr>
          <p:grpSpPr>
            <a:xfrm>
              <a:off x="1372800" y="4441494"/>
              <a:ext cx="2188016" cy="542226"/>
              <a:chOff x="4101019" y="11270157"/>
              <a:chExt cx="1970768" cy="510076"/>
            </a:xfrm>
          </p:grpSpPr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BBF466BA-58A5-1E1D-DC2B-E778175C7866}"/>
                  </a:ext>
                </a:extLst>
              </p:cNvPr>
              <p:cNvGrpSpPr/>
              <p:nvPr/>
            </p:nvGrpSpPr>
            <p:grpSpPr>
              <a:xfrm rot="16200000">
                <a:off x="4347451" y="11023725"/>
                <a:ext cx="510076" cy="1002940"/>
                <a:chOff x="1267252" y="7648201"/>
                <a:chExt cx="510076" cy="1002940"/>
              </a:xfrm>
            </p:grpSpPr>
            <p:sp>
              <p:nvSpPr>
                <p:cNvPr id="94" name="Rectangle 93">
                  <a:extLst>
                    <a:ext uri="{FF2B5EF4-FFF2-40B4-BE49-F238E27FC236}">
                      <a16:creationId xmlns:a16="http://schemas.microsoft.com/office/drawing/2014/main" id="{B0BB15AD-FE6D-D8A0-A86C-A12B29FC627F}"/>
                    </a:ext>
                  </a:extLst>
                </p:cNvPr>
                <p:cNvSpPr/>
                <p:nvPr/>
              </p:nvSpPr>
              <p:spPr>
                <a:xfrm>
                  <a:off x="1305724" y="764820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5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B82D0AED-67C8-C8A3-2D3B-C793C19503CE}"/>
                    </a:ext>
                  </a:extLst>
                </p:cNvPr>
                <p:cNvSpPr txBox="1"/>
                <p:nvPr/>
              </p:nvSpPr>
              <p:spPr>
                <a:xfrm>
                  <a:off x="1267252" y="7755923"/>
                  <a:ext cx="4988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>
                      <a:solidFill>
                        <a:srgbClr val="0070C0"/>
                      </a:solidFill>
                    </a:rPr>
                    <a:t>wriLr34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816F97EE-4390-01D8-804A-01371599335B}"/>
                    </a:ext>
                  </a:extLst>
                </p:cNvPr>
                <p:cNvSpPr txBox="1"/>
                <p:nvPr/>
              </p:nvSpPr>
              <p:spPr>
                <a:xfrm>
                  <a:off x="1323358" y="7865233"/>
                  <a:ext cx="4539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 err="1">
                      <a:solidFill>
                        <a:srgbClr val="0070C0"/>
                      </a:solidFill>
                    </a:rPr>
                    <a:t>wriXat</a:t>
                  </a:r>
                  <a:endParaRPr lang="en-AU" sz="800" dirty="0">
                    <a:solidFill>
                      <a:srgbClr val="0070C0"/>
                    </a:solidFill>
                  </a:endParaRPr>
                </a:p>
              </p:txBody>
            </p:sp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38FEC460-E0CC-7D3D-0D1A-500E8490CEE3}"/>
                    </a:ext>
                  </a:extLst>
                </p:cNvPr>
                <p:cNvSpPr/>
                <p:nvPr/>
              </p:nvSpPr>
              <p:spPr>
                <a:xfrm>
                  <a:off x="1305724" y="7976130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6</a:t>
                  </a:r>
                </a:p>
              </p:txBody>
            </p:sp>
            <p:sp>
              <p:nvSpPr>
                <p:cNvPr id="98" name="Rectangle 97">
                  <a:extLst>
                    <a:ext uri="{FF2B5EF4-FFF2-40B4-BE49-F238E27FC236}">
                      <a16:creationId xmlns:a16="http://schemas.microsoft.com/office/drawing/2014/main" id="{64C43760-401F-B3CF-F53A-B3A93A45904D}"/>
                    </a:ext>
                  </a:extLst>
                </p:cNvPr>
                <p:cNvSpPr/>
                <p:nvPr/>
              </p:nvSpPr>
              <p:spPr>
                <a:xfrm>
                  <a:off x="1305724" y="809306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7</a:t>
                  </a:r>
                </a:p>
              </p:txBody>
            </p:sp>
            <p:sp>
              <p:nvSpPr>
                <p:cNvPr id="99" name="Rectangle 98">
                  <a:extLst>
                    <a:ext uri="{FF2B5EF4-FFF2-40B4-BE49-F238E27FC236}">
                      <a16:creationId xmlns:a16="http://schemas.microsoft.com/office/drawing/2014/main" id="{8C5BAC18-720B-0140-2BA2-A0A80F0121D8}"/>
                    </a:ext>
                  </a:extLst>
                </p:cNvPr>
                <p:cNvSpPr/>
                <p:nvPr/>
              </p:nvSpPr>
              <p:spPr>
                <a:xfrm>
                  <a:off x="1305724" y="8207273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8</a:t>
                  </a:r>
                </a:p>
              </p:txBody>
            </p:sp>
            <p:sp>
              <p:nvSpPr>
                <p:cNvPr id="100" name="Rectangle 99">
                  <a:extLst>
                    <a:ext uri="{FF2B5EF4-FFF2-40B4-BE49-F238E27FC236}">
                      <a16:creationId xmlns:a16="http://schemas.microsoft.com/office/drawing/2014/main" id="{10B02790-D9DC-CB97-6D7C-13D00C34710B}"/>
                    </a:ext>
                  </a:extLst>
                </p:cNvPr>
                <p:cNvSpPr/>
                <p:nvPr/>
              </p:nvSpPr>
              <p:spPr>
                <a:xfrm>
                  <a:off x="1305724" y="8314995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9</a:t>
                  </a:r>
                </a:p>
              </p:txBody>
            </p:sp>
            <p:sp>
              <p:nvSpPr>
                <p:cNvPr id="101" name="Rectangle 100">
                  <a:extLst>
                    <a:ext uri="{FF2B5EF4-FFF2-40B4-BE49-F238E27FC236}">
                      <a16:creationId xmlns:a16="http://schemas.microsoft.com/office/drawing/2014/main" id="{9A073A60-F927-5AFB-51B8-EB82B093002B}"/>
                    </a:ext>
                  </a:extLst>
                </p:cNvPr>
                <p:cNvSpPr/>
                <p:nvPr/>
              </p:nvSpPr>
              <p:spPr>
                <a:xfrm>
                  <a:off x="1305724" y="8435697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60</a:t>
                  </a:r>
                </a:p>
              </p:txBody>
            </p:sp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E5CA7C9B-84C5-3BC2-7BA7-46E88FF3E467}"/>
                  </a:ext>
                </a:extLst>
              </p:cNvPr>
              <p:cNvGrpSpPr/>
              <p:nvPr/>
            </p:nvGrpSpPr>
            <p:grpSpPr>
              <a:xfrm rot="16200000">
                <a:off x="5315279" y="11023725"/>
                <a:ext cx="510076" cy="1002940"/>
                <a:chOff x="1267252" y="7648201"/>
                <a:chExt cx="510076" cy="1002940"/>
              </a:xfrm>
            </p:grpSpPr>
            <p:sp>
              <p:nvSpPr>
                <p:cNvPr id="86" name="Rectangle 85">
                  <a:extLst>
                    <a:ext uri="{FF2B5EF4-FFF2-40B4-BE49-F238E27FC236}">
                      <a16:creationId xmlns:a16="http://schemas.microsoft.com/office/drawing/2014/main" id="{C0DC0296-3AA6-210D-1258-BE6A487CE123}"/>
                    </a:ext>
                  </a:extLst>
                </p:cNvPr>
                <p:cNvSpPr/>
                <p:nvPr/>
              </p:nvSpPr>
              <p:spPr>
                <a:xfrm>
                  <a:off x="1305724" y="764820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5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D91D01D1-35D0-B5B8-02BA-80FF88CF677C}"/>
                    </a:ext>
                  </a:extLst>
                </p:cNvPr>
                <p:cNvSpPr txBox="1"/>
                <p:nvPr/>
              </p:nvSpPr>
              <p:spPr>
                <a:xfrm>
                  <a:off x="1267252" y="7755923"/>
                  <a:ext cx="4988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>
                      <a:solidFill>
                        <a:srgbClr val="0070C0"/>
                      </a:solidFill>
                    </a:rPr>
                    <a:t>wriLr34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6F559E83-D3A4-BBB6-8F1B-DE2FC3545EB6}"/>
                    </a:ext>
                  </a:extLst>
                </p:cNvPr>
                <p:cNvSpPr txBox="1"/>
                <p:nvPr/>
              </p:nvSpPr>
              <p:spPr>
                <a:xfrm>
                  <a:off x="1323358" y="7865233"/>
                  <a:ext cx="4539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 err="1">
                      <a:solidFill>
                        <a:srgbClr val="0070C0"/>
                      </a:solidFill>
                    </a:rPr>
                    <a:t>wriXat</a:t>
                  </a:r>
                  <a:endParaRPr lang="en-AU" sz="800" dirty="0">
                    <a:solidFill>
                      <a:srgbClr val="0070C0"/>
                    </a:solidFill>
                  </a:endParaRPr>
                </a:p>
              </p:txBody>
            </p:sp>
            <p:sp>
              <p:nvSpPr>
                <p:cNvPr id="89" name="Rectangle 88">
                  <a:extLst>
                    <a:ext uri="{FF2B5EF4-FFF2-40B4-BE49-F238E27FC236}">
                      <a16:creationId xmlns:a16="http://schemas.microsoft.com/office/drawing/2014/main" id="{33357F22-148D-5162-747D-13CBA46D5F3C}"/>
                    </a:ext>
                  </a:extLst>
                </p:cNvPr>
                <p:cNvSpPr/>
                <p:nvPr/>
              </p:nvSpPr>
              <p:spPr>
                <a:xfrm>
                  <a:off x="1305724" y="7976130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6</a:t>
                  </a:r>
                </a:p>
              </p:txBody>
            </p:sp>
            <p:sp>
              <p:nvSpPr>
                <p:cNvPr id="90" name="Rectangle 89">
                  <a:extLst>
                    <a:ext uri="{FF2B5EF4-FFF2-40B4-BE49-F238E27FC236}">
                      <a16:creationId xmlns:a16="http://schemas.microsoft.com/office/drawing/2014/main" id="{F7B16B03-F7E5-7CD0-3905-4F8BFA6DA828}"/>
                    </a:ext>
                  </a:extLst>
                </p:cNvPr>
                <p:cNvSpPr/>
                <p:nvPr/>
              </p:nvSpPr>
              <p:spPr>
                <a:xfrm>
                  <a:off x="1305724" y="809306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7</a:t>
                  </a:r>
                </a:p>
              </p:txBody>
            </p:sp>
            <p:sp>
              <p:nvSpPr>
                <p:cNvPr id="91" name="Rectangle 90">
                  <a:extLst>
                    <a:ext uri="{FF2B5EF4-FFF2-40B4-BE49-F238E27FC236}">
                      <a16:creationId xmlns:a16="http://schemas.microsoft.com/office/drawing/2014/main" id="{8AABC3C4-DC84-0105-A57E-67F8A05815A7}"/>
                    </a:ext>
                  </a:extLst>
                </p:cNvPr>
                <p:cNvSpPr/>
                <p:nvPr/>
              </p:nvSpPr>
              <p:spPr>
                <a:xfrm>
                  <a:off x="1305724" y="8207273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8</a:t>
                  </a:r>
                </a:p>
              </p:txBody>
            </p:sp>
            <p:sp>
              <p:nvSpPr>
                <p:cNvPr id="92" name="Rectangle 91">
                  <a:extLst>
                    <a:ext uri="{FF2B5EF4-FFF2-40B4-BE49-F238E27FC236}">
                      <a16:creationId xmlns:a16="http://schemas.microsoft.com/office/drawing/2014/main" id="{C0A10C98-D714-9692-C71F-2FA3D9DAF3AB}"/>
                    </a:ext>
                  </a:extLst>
                </p:cNvPr>
                <p:cNvSpPr/>
                <p:nvPr/>
              </p:nvSpPr>
              <p:spPr>
                <a:xfrm>
                  <a:off x="1305724" y="8314995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9</a:t>
                  </a:r>
                </a:p>
              </p:txBody>
            </p:sp>
            <p:sp>
              <p:nvSpPr>
                <p:cNvPr id="93" name="Rectangle 92">
                  <a:extLst>
                    <a:ext uri="{FF2B5EF4-FFF2-40B4-BE49-F238E27FC236}">
                      <a16:creationId xmlns:a16="http://schemas.microsoft.com/office/drawing/2014/main" id="{373FEF57-FAA0-54DC-F3F4-36958A0405DA}"/>
                    </a:ext>
                  </a:extLst>
                </p:cNvPr>
                <p:cNvSpPr/>
                <p:nvPr/>
              </p:nvSpPr>
              <p:spPr>
                <a:xfrm>
                  <a:off x="1305724" y="8435697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60</a:t>
                  </a:r>
                </a:p>
              </p:txBody>
            </p:sp>
          </p:grp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CCF41E3F-0D98-EC3B-17D4-8146792B6D7B}"/>
                </a:ext>
              </a:extLst>
            </p:cNvPr>
            <p:cNvGrpSpPr/>
            <p:nvPr/>
          </p:nvGrpSpPr>
          <p:grpSpPr>
            <a:xfrm>
              <a:off x="3812764" y="1012356"/>
              <a:ext cx="3178586" cy="4071727"/>
              <a:chOff x="3520210" y="3275294"/>
              <a:chExt cx="2862985" cy="3830302"/>
            </a:xfrm>
          </p:grpSpPr>
          <p:graphicFrame>
            <p:nvGraphicFramePr>
              <p:cNvPr id="65" name="Object 64">
                <a:extLst>
                  <a:ext uri="{FF2B5EF4-FFF2-40B4-BE49-F238E27FC236}">
                    <a16:creationId xmlns:a16="http://schemas.microsoft.com/office/drawing/2014/main" id="{381BAAD0-269D-058E-86AF-EE8B0B4225C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16049091"/>
                  </p:ext>
                </p:extLst>
              </p:nvPr>
            </p:nvGraphicFramePr>
            <p:xfrm>
              <a:off x="3520210" y="3275294"/>
              <a:ext cx="2862985" cy="368975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Document" r:id="rId6" imgW="5725970" imgH="7379518" progId="Word.Document.12">
                      <p:embed/>
                    </p:oleObj>
                  </mc:Choice>
                  <mc:Fallback>
                    <p:oleObj name="Document" r:id="rId6" imgW="5725970" imgH="7379518" progId="Word.Document.12">
                      <p:embed/>
                      <p:pic>
                        <p:nvPicPr>
                          <p:cNvPr id="87" name="Object 86">
                            <a:extLst>
                              <a:ext uri="{FF2B5EF4-FFF2-40B4-BE49-F238E27FC236}">
                                <a16:creationId xmlns:a16="http://schemas.microsoft.com/office/drawing/2014/main" id="{84637998-4000-C1AE-B394-A24FCDC80B5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3520210" y="3275294"/>
                            <a:ext cx="2862985" cy="368975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7D03D851-B19D-CB8C-64B3-1D94D6867BF2}"/>
                  </a:ext>
                </a:extLst>
              </p:cNvPr>
              <p:cNvGrpSpPr/>
              <p:nvPr/>
            </p:nvGrpSpPr>
            <p:grpSpPr>
              <a:xfrm rot="16200000">
                <a:off x="4226440" y="6349087"/>
                <a:ext cx="510076" cy="1002940"/>
                <a:chOff x="1267252" y="7648201"/>
                <a:chExt cx="510076" cy="1002940"/>
              </a:xfrm>
            </p:grpSpPr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3741DDD5-9B33-B8FA-CEF8-0C6C92046BFF}"/>
                    </a:ext>
                  </a:extLst>
                </p:cNvPr>
                <p:cNvSpPr/>
                <p:nvPr/>
              </p:nvSpPr>
              <p:spPr>
                <a:xfrm>
                  <a:off x="1305724" y="764820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5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43830E35-5C1F-06FA-E906-07C17E8D6A71}"/>
                    </a:ext>
                  </a:extLst>
                </p:cNvPr>
                <p:cNvSpPr txBox="1"/>
                <p:nvPr/>
              </p:nvSpPr>
              <p:spPr>
                <a:xfrm>
                  <a:off x="1267252" y="7755923"/>
                  <a:ext cx="4988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>
                      <a:solidFill>
                        <a:srgbClr val="0070C0"/>
                      </a:solidFill>
                    </a:rPr>
                    <a:t>wriLr34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F4AC33A1-8674-6018-FA8E-8E109B93BAA8}"/>
                    </a:ext>
                  </a:extLst>
                </p:cNvPr>
                <p:cNvSpPr txBox="1"/>
                <p:nvPr/>
              </p:nvSpPr>
              <p:spPr>
                <a:xfrm>
                  <a:off x="1323358" y="7865233"/>
                  <a:ext cx="4539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 err="1">
                      <a:solidFill>
                        <a:srgbClr val="0070C0"/>
                      </a:solidFill>
                    </a:rPr>
                    <a:t>wriXat</a:t>
                  </a:r>
                  <a:endParaRPr lang="en-AU" sz="800" dirty="0">
                    <a:solidFill>
                      <a:srgbClr val="0070C0"/>
                    </a:solidFill>
                  </a:endParaRPr>
                </a:p>
              </p:txBody>
            </p:sp>
            <p:sp>
              <p:nvSpPr>
                <p:cNvPr id="79" name="Rectangle 78">
                  <a:extLst>
                    <a:ext uri="{FF2B5EF4-FFF2-40B4-BE49-F238E27FC236}">
                      <a16:creationId xmlns:a16="http://schemas.microsoft.com/office/drawing/2014/main" id="{B4B252F6-76B9-2456-973F-F3DF6CDC303E}"/>
                    </a:ext>
                  </a:extLst>
                </p:cNvPr>
                <p:cNvSpPr/>
                <p:nvPr/>
              </p:nvSpPr>
              <p:spPr>
                <a:xfrm>
                  <a:off x="1305724" y="7976130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6</a:t>
                  </a:r>
                </a:p>
              </p:txBody>
            </p:sp>
            <p:sp>
              <p:nvSpPr>
                <p:cNvPr id="80" name="Rectangle 79">
                  <a:extLst>
                    <a:ext uri="{FF2B5EF4-FFF2-40B4-BE49-F238E27FC236}">
                      <a16:creationId xmlns:a16="http://schemas.microsoft.com/office/drawing/2014/main" id="{0A64642D-3DBC-0AC0-75B6-8AC038FBD847}"/>
                    </a:ext>
                  </a:extLst>
                </p:cNvPr>
                <p:cNvSpPr/>
                <p:nvPr/>
              </p:nvSpPr>
              <p:spPr>
                <a:xfrm>
                  <a:off x="1305724" y="809306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7</a:t>
                  </a:r>
                </a:p>
              </p:txBody>
            </p: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9CBE9EB2-63CA-A5B7-E3AE-936A97B4AD49}"/>
                    </a:ext>
                  </a:extLst>
                </p:cNvPr>
                <p:cNvSpPr/>
                <p:nvPr/>
              </p:nvSpPr>
              <p:spPr>
                <a:xfrm>
                  <a:off x="1305724" y="8207273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8</a:t>
                  </a:r>
                </a:p>
              </p:txBody>
            </p:sp>
            <p:sp>
              <p:nvSpPr>
                <p:cNvPr id="82" name="Rectangle 81">
                  <a:extLst>
                    <a:ext uri="{FF2B5EF4-FFF2-40B4-BE49-F238E27FC236}">
                      <a16:creationId xmlns:a16="http://schemas.microsoft.com/office/drawing/2014/main" id="{07FB0BDE-C047-DEA9-0596-308A324458F6}"/>
                    </a:ext>
                  </a:extLst>
                </p:cNvPr>
                <p:cNvSpPr/>
                <p:nvPr/>
              </p:nvSpPr>
              <p:spPr>
                <a:xfrm>
                  <a:off x="1305724" y="8314995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9</a:t>
                  </a:r>
                </a:p>
              </p:txBody>
            </p:sp>
            <p:sp>
              <p:nvSpPr>
                <p:cNvPr id="83" name="Rectangle 82">
                  <a:extLst>
                    <a:ext uri="{FF2B5EF4-FFF2-40B4-BE49-F238E27FC236}">
                      <a16:creationId xmlns:a16="http://schemas.microsoft.com/office/drawing/2014/main" id="{A41B0098-82E3-E64E-A22B-66F80254F575}"/>
                    </a:ext>
                  </a:extLst>
                </p:cNvPr>
                <p:cNvSpPr/>
                <p:nvPr/>
              </p:nvSpPr>
              <p:spPr>
                <a:xfrm>
                  <a:off x="1305724" y="8435697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60</a:t>
                  </a:r>
                </a:p>
              </p:txBody>
            </p:sp>
          </p:grp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7E75B1BD-8F88-D619-E550-800634242C2B}"/>
                  </a:ext>
                </a:extLst>
              </p:cNvPr>
              <p:cNvGrpSpPr/>
              <p:nvPr/>
            </p:nvGrpSpPr>
            <p:grpSpPr>
              <a:xfrm rot="16200000">
                <a:off x="5184232" y="6349088"/>
                <a:ext cx="510076" cy="1002940"/>
                <a:chOff x="1267252" y="7648201"/>
                <a:chExt cx="510076" cy="1002940"/>
              </a:xfrm>
            </p:grpSpPr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88980E09-836F-5E12-41BB-531E7C4355B0}"/>
                    </a:ext>
                  </a:extLst>
                </p:cNvPr>
                <p:cNvSpPr/>
                <p:nvPr/>
              </p:nvSpPr>
              <p:spPr>
                <a:xfrm>
                  <a:off x="1305724" y="764820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5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0C19F3C4-C2BC-0E06-2149-1ED6F94A0F00}"/>
                    </a:ext>
                  </a:extLst>
                </p:cNvPr>
                <p:cNvSpPr txBox="1"/>
                <p:nvPr/>
              </p:nvSpPr>
              <p:spPr>
                <a:xfrm>
                  <a:off x="1267252" y="7755923"/>
                  <a:ext cx="4988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>
                      <a:solidFill>
                        <a:srgbClr val="0070C0"/>
                      </a:solidFill>
                    </a:rPr>
                    <a:t>wriLr34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BF31D17B-010B-D95C-5B8E-EF4BE4BD47F4}"/>
                    </a:ext>
                  </a:extLst>
                </p:cNvPr>
                <p:cNvSpPr txBox="1"/>
                <p:nvPr/>
              </p:nvSpPr>
              <p:spPr>
                <a:xfrm>
                  <a:off x="1323358" y="7865233"/>
                  <a:ext cx="4539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 err="1">
                      <a:solidFill>
                        <a:srgbClr val="0070C0"/>
                      </a:solidFill>
                    </a:rPr>
                    <a:t>wriXat</a:t>
                  </a:r>
                  <a:endParaRPr lang="en-AU" sz="800" dirty="0">
                    <a:solidFill>
                      <a:srgbClr val="0070C0"/>
                    </a:solidFill>
                  </a:endParaRPr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3A5DCEAB-578C-BC8A-B14E-8DDD5438131E}"/>
                    </a:ext>
                  </a:extLst>
                </p:cNvPr>
                <p:cNvSpPr/>
                <p:nvPr/>
              </p:nvSpPr>
              <p:spPr>
                <a:xfrm>
                  <a:off x="1305724" y="7976130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6</a:t>
                  </a:r>
                </a:p>
              </p:txBody>
            </p:sp>
            <p:sp>
              <p:nvSpPr>
                <p:cNvPr id="72" name="Rectangle 71">
                  <a:extLst>
                    <a:ext uri="{FF2B5EF4-FFF2-40B4-BE49-F238E27FC236}">
                      <a16:creationId xmlns:a16="http://schemas.microsoft.com/office/drawing/2014/main" id="{739B0373-44A1-789E-CC03-FF92B6BBF81F}"/>
                    </a:ext>
                  </a:extLst>
                </p:cNvPr>
                <p:cNvSpPr/>
                <p:nvPr/>
              </p:nvSpPr>
              <p:spPr>
                <a:xfrm>
                  <a:off x="1305724" y="8093061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7</a:t>
                  </a:r>
                </a:p>
              </p:txBody>
            </p:sp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EC4A045A-C556-90A3-3F2A-3736EFCF41CD}"/>
                    </a:ext>
                  </a:extLst>
                </p:cNvPr>
                <p:cNvSpPr/>
                <p:nvPr/>
              </p:nvSpPr>
              <p:spPr>
                <a:xfrm>
                  <a:off x="1305724" y="8207273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8</a:t>
                  </a:r>
                </a:p>
              </p:txBody>
            </p:sp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A2A28644-14A0-CF7C-ECB5-36040B9EB0BC}"/>
                    </a:ext>
                  </a:extLst>
                </p:cNvPr>
                <p:cNvSpPr/>
                <p:nvPr/>
              </p:nvSpPr>
              <p:spPr>
                <a:xfrm>
                  <a:off x="1305724" y="8314995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59</a:t>
                  </a:r>
                </a:p>
              </p:txBody>
            </p:sp>
            <p:sp>
              <p:nvSpPr>
                <p:cNvPr id="75" name="Rectangle 74">
                  <a:extLst>
                    <a:ext uri="{FF2B5EF4-FFF2-40B4-BE49-F238E27FC236}">
                      <a16:creationId xmlns:a16="http://schemas.microsoft.com/office/drawing/2014/main" id="{759318AB-6064-3C79-1E2C-23CD8DF9D6FC}"/>
                    </a:ext>
                  </a:extLst>
                </p:cNvPr>
                <p:cNvSpPr/>
                <p:nvPr/>
              </p:nvSpPr>
              <p:spPr>
                <a:xfrm>
                  <a:off x="1305724" y="8435697"/>
                  <a:ext cx="47160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AU" sz="800" dirty="0"/>
                    <a:t>wri860</a:t>
                  </a:r>
                </a:p>
              </p:txBody>
            </p:sp>
          </p:grpSp>
        </p:grp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7FDA4933-81CB-86D0-4D0E-76C6CC4937DD}"/>
              </a:ext>
            </a:extLst>
          </p:cNvPr>
          <p:cNvSpPr txBox="1"/>
          <p:nvPr/>
        </p:nvSpPr>
        <p:spPr>
          <a:xfrm>
            <a:off x="7265828" y="1588439"/>
            <a:ext cx="4436214" cy="4267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1: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ASP marker analysis of BC1F2 plants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C1F2 plants were genotyped with eight KASP markers labelled at the bottom of the figure with two dominant markers shown in blue and six co-dominant markers shown in black. These markers are distributed across chromosomes 7D and 7A (short arm to long arm, left to right). Each yellow/pink row represents a chromosome haplotype with two chromosomes shown for each BC1F2 genotype. Alleles on each karyotype are shown as either pink boxes labelled D (D alleles) or yellow boxes labelled A (A alleles). To minimise the number of proposed recombination events and recombinant chromosomes, dominant markers wriLr34 and </a:t>
            </a:r>
            <a:r>
              <a:rPr lang="en-AU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riXat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ere scored as homozygous when flanked by homozygous markers. In cases where zygosity could not be assigned to dominant markers the data points are shown as blue/grey boxes. White boxes show missing datapoints. Samples marked with black asterisks were identified as being 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sitive but having less than 10% 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gas44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equence. Plant 43-2 (marked with X and containing 13% 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gas44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equence) and those plants marked with a red asterisk, which contain a recombinant 7D/7A chromosome and wild type 7D chromosome, were used for further analysis as described in the text.</a:t>
            </a: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AU" sz="12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120D19EB-3ED5-826F-9861-623D207B4CBE}"/>
              </a:ext>
            </a:extLst>
          </p:cNvPr>
          <p:cNvSpPr txBox="1"/>
          <p:nvPr/>
        </p:nvSpPr>
        <p:spPr>
          <a:xfrm>
            <a:off x="8963025" y="169723"/>
            <a:ext cx="2497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l Figure S1  </a:t>
            </a:r>
          </a:p>
        </p:txBody>
      </p:sp>
    </p:spTree>
    <p:extLst>
      <p:ext uri="{BB962C8B-B14F-4D97-AF65-F5344CB8AC3E}">
        <p14:creationId xmlns:p14="http://schemas.microsoft.com/office/powerpoint/2010/main" val="2156811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2C6DD72-4E4A-4BFF-900C-F7853ED4BEE5}"/>
              </a:ext>
            </a:extLst>
          </p:cNvPr>
          <p:cNvSpPr txBox="1"/>
          <p:nvPr/>
        </p:nvSpPr>
        <p:spPr>
          <a:xfrm>
            <a:off x="8963025" y="169723"/>
            <a:ext cx="2497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l Figure S2  </a:t>
            </a:r>
          </a:p>
        </p:txBody>
      </p:sp>
      <p:pic>
        <p:nvPicPr>
          <p:cNvPr id="3" name="Picture 2" descr="A whiteboard with writing on it&#10;&#10;Description automatically generated with low confidence">
            <a:extLst>
              <a:ext uri="{FF2B5EF4-FFF2-40B4-BE49-F238E27FC236}">
                <a16:creationId xmlns:a16="http://schemas.microsoft.com/office/drawing/2014/main" id="{8D671038-5432-44DE-8A91-A1F0AA6F64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449" t="18019" r="29699" b="26688"/>
          <a:stretch/>
        </p:blipFill>
        <p:spPr>
          <a:xfrm rot="16200000">
            <a:off x="5219395" y="657532"/>
            <a:ext cx="1162050" cy="46856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54C9D8-6028-4C85-B4B6-03060447BCB9}"/>
              </a:ext>
            </a:extLst>
          </p:cNvPr>
          <p:cNvSpPr txBox="1"/>
          <p:nvPr/>
        </p:nvSpPr>
        <p:spPr>
          <a:xfrm>
            <a:off x="1609725" y="4000500"/>
            <a:ext cx="89725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Figure S2: </a:t>
            </a:r>
            <a:r>
              <a:rPr lang="en-AU" sz="1400" dirty="0"/>
              <a:t>PCR confirmation on </a:t>
            </a:r>
            <a:r>
              <a:rPr lang="en-AU" sz="1400" i="1" dirty="0"/>
              <a:t>Lr34</a:t>
            </a:r>
            <a:r>
              <a:rPr lang="en-AU" sz="1400" dirty="0"/>
              <a:t> genotypes in Bansi lines grown in the 2020 field season. DNA was extracted from field grown material and PCR amplified with primers specific for the </a:t>
            </a:r>
            <a:r>
              <a:rPr lang="en-AU" sz="1400" i="1" dirty="0"/>
              <a:t>Lr34</a:t>
            </a:r>
            <a:r>
              <a:rPr lang="en-AU" sz="1400" dirty="0"/>
              <a:t> resistance allele (see Table 1) and products then run on an agarose gel (negative image shown). The upper band (arrowed) indicates the presence of the </a:t>
            </a:r>
            <a:r>
              <a:rPr lang="en-AU" sz="1400" i="1" dirty="0"/>
              <a:t>Lr34</a:t>
            </a:r>
            <a:r>
              <a:rPr lang="en-AU" sz="1400" dirty="0"/>
              <a:t> resistance allele while the lower band is a background product common to all lines. Samples were as follows (1) Bansi Lr34-13-1, (2) Bansi 13-7 null, (3) Bansi Lr34-15-9, (4) Bansi 13 null, (5) Bansi, (6) no DNA control, (7) Lr34 positive control (8) 1 kb Plus molecular weight marker (Invitrogen)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FE2FEA-2B6E-4935-A47E-34CFE84E553A}"/>
              </a:ext>
            </a:extLst>
          </p:cNvPr>
          <p:cNvSpPr txBox="1"/>
          <p:nvPr/>
        </p:nvSpPr>
        <p:spPr>
          <a:xfrm>
            <a:off x="3619500" y="20002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BC38E9-1D28-4653-A260-7693460907ED}"/>
              </a:ext>
            </a:extLst>
          </p:cNvPr>
          <p:cNvSpPr txBox="1"/>
          <p:nvPr/>
        </p:nvSpPr>
        <p:spPr>
          <a:xfrm>
            <a:off x="5391150" y="19965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AC1419-AFE5-4AF3-9DB1-EB8313FEF7D7}"/>
              </a:ext>
            </a:extLst>
          </p:cNvPr>
          <p:cNvSpPr txBox="1"/>
          <p:nvPr/>
        </p:nvSpPr>
        <p:spPr>
          <a:xfrm>
            <a:off x="4800600" y="20002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6435E54-BD7B-43CD-8A47-5118CE5B5BE0}"/>
              </a:ext>
            </a:extLst>
          </p:cNvPr>
          <p:cNvSpPr txBox="1"/>
          <p:nvPr/>
        </p:nvSpPr>
        <p:spPr>
          <a:xfrm>
            <a:off x="4210050" y="20002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713ED4-0F85-42A0-A9FE-2C362C763272}"/>
              </a:ext>
            </a:extLst>
          </p:cNvPr>
          <p:cNvSpPr txBox="1"/>
          <p:nvPr/>
        </p:nvSpPr>
        <p:spPr>
          <a:xfrm>
            <a:off x="5945157" y="19965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73893E-DF2B-450A-8F4E-33F7A9F782B1}"/>
              </a:ext>
            </a:extLst>
          </p:cNvPr>
          <p:cNvSpPr txBox="1"/>
          <p:nvPr/>
        </p:nvSpPr>
        <p:spPr>
          <a:xfrm>
            <a:off x="7011957" y="19965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CAED19E-2C60-48D5-B141-66EBEB2683AE}"/>
              </a:ext>
            </a:extLst>
          </p:cNvPr>
          <p:cNvSpPr txBox="1"/>
          <p:nvPr/>
        </p:nvSpPr>
        <p:spPr>
          <a:xfrm>
            <a:off x="6421407" y="19965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2FD262A-2C5D-43C6-A299-3AF071C2671B}"/>
              </a:ext>
            </a:extLst>
          </p:cNvPr>
          <p:cNvSpPr txBox="1"/>
          <p:nvPr/>
        </p:nvSpPr>
        <p:spPr>
          <a:xfrm>
            <a:off x="7620000" y="19965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8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C8703CB-7B79-CACC-5837-84A150D694FE}"/>
              </a:ext>
            </a:extLst>
          </p:cNvPr>
          <p:cNvCxnSpPr>
            <a:cxnSpLocks/>
          </p:cNvCxnSpPr>
          <p:nvPr/>
        </p:nvCxnSpPr>
        <p:spPr>
          <a:xfrm>
            <a:off x="3038475" y="2600325"/>
            <a:ext cx="36195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42487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2190CDE-05DE-F38D-ADAD-2413AE733F34}"/>
              </a:ext>
            </a:extLst>
          </p:cNvPr>
          <p:cNvSpPr txBox="1"/>
          <p:nvPr/>
        </p:nvSpPr>
        <p:spPr>
          <a:xfrm>
            <a:off x="8963025" y="169723"/>
            <a:ext cx="2497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l Figure S3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BB213A0-2D2C-622C-B4FA-0EA9B80C4D89}"/>
              </a:ext>
            </a:extLst>
          </p:cNvPr>
          <p:cNvSpPr txBox="1"/>
          <p:nvPr/>
        </p:nvSpPr>
        <p:spPr>
          <a:xfrm>
            <a:off x="880952" y="513213"/>
            <a:ext cx="10443335" cy="30436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AU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urum haplotype variation of the</a:t>
            </a:r>
            <a:r>
              <a:rPr lang="en-AU" sz="10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r34</a:t>
            </a:r>
            <a:r>
              <a:rPr lang="en-AU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AU" sz="10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suedogene</a:t>
            </a:r>
            <a:r>
              <a:rPr lang="en-AU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esent on chromosome 7A of durum wheat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indent="457200">
              <a:lnSpc>
                <a:spcPct val="150000"/>
              </a:lnSpc>
              <a:spcAft>
                <a:spcPts val="800"/>
              </a:spcAft>
            </a:pP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 interesting feature arising from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r34 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NA blot analysis was the presence of a 3 kb fragment, with homology to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 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be, present in bread wheat cultivars Fielder (see Figure 6B, lane 8), Robin  and durum Cappelli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1c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ut absent in durum cultivars Bansi and Langdon (Figure S1 below). Analysis of the Chinese Spring genome sequence, and previous DNA blot analyses (Krattinger et al. 2011) indicates that three </a:t>
            </a:r>
            <a:r>
              <a:rPr lang="en-AU" sz="10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co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striction fragments with homology to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obe used are predicted; these being from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 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e on chromosome 7D (2.2 kb), a pseudogene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moeologue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n 7A (3.1 kb) and a potentially functional orthologous gene on  chromosomes 4A (6.2 kb), believed to be a translocation of the ancestral chromosome 7B homologue (Krattinger et al. 2011). This predicted hybridisation pattern was observed in bread wheat cultivars Robin and Fielder (see Figure 6B, lane 8 of manuscript) while the 3.1 kb fragment encoded by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suedogene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omologue on chromosome 7A was polymorphic between the tetraploid genomes of Cappelli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1c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Langdon and Bansi (below).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indent="457200">
              <a:lnSpc>
                <a:spcPct val="150000"/>
              </a:lnSpc>
              <a:spcAft>
                <a:spcPts val="800"/>
              </a:spcAft>
            </a:pP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AST comparisons of the available tetraploid genomes of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vevo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avitan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ith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obe sequence identifies a highly homologous sequence (98% identical) on chromosome 4A and little homology (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.e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&lt;70%) elsewhere in these genomes, consistent with the absence of the 7A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seudogene (3.1 kb </a:t>
            </a:r>
            <a:r>
              <a:rPr lang="en-AU" sz="10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co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ragment) in Bansi and Langdon.  However, chromosome 7A of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avitan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oes contain a region of significant homology (92-98% identity) to a 1.1 kb region of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 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NA sequence, that was not encompassed by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obe used for DNA blots, indicating the gene has not been completely deleted in this cultivar. This homologous sequence is located at the 50 Mb region of 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avitan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hromosome 7A, which is similar to the 47 Mb location of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n chromosome 7D of Chinese Spring. These data indicate variation existing between these durum lines for the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seudogene region on chromosome 7A.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80A9B44-D3F7-BA4A-93D1-F254DEA2633E}"/>
              </a:ext>
            </a:extLst>
          </p:cNvPr>
          <p:cNvSpPr txBox="1"/>
          <p:nvPr/>
        </p:nvSpPr>
        <p:spPr>
          <a:xfrm>
            <a:off x="1144519" y="5764387"/>
            <a:ext cx="9609206" cy="760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AU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DNA Blot showing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oci present  in durum chromosome substitution line LDN 7D(7A), wild type Langdon, Cappelli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1c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urum, durum cultivar Bansi and bread wheat cultivar Robin, respectively. DNAs were </a:t>
            </a:r>
            <a:r>
              <a:rPr lang="en-AU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ges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d with </a:t>
            </a:r>
            <a:r>
              <a:rPr lang="en-AU" sz="10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co</a:t>
            </a:r>
            <a:r>
              <a:rPr lang="en-AU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hybridised with an </a:t>
            </a:r>
            <a:r>
              <a:rPr lang="en-AU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r34</a:t>
            </a:r>
            <a:r>
              <a:rPr lang="en-AU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pecific probe. A molecular weight marker in the last lane shows molecular weights of 6, 5, 4, 3 and 2 kb. </a:t>
            </a:r>
            <a:r>
              <a:rPr lang="en-AU" sz="10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te: this image is a region from the same image shown in Fig. 6C of the manuscript</a:t>
            </a:r>
            <a:r>
              <a:rPr lang="en-AU" sz="1000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.e. (lanes 13-18).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30CE8AA8-1F3E-F8AA-D422-D7DE3584CFA7}"/>
              </a:ext>
            </a:extLst>
          </p:cNvPr>
          <p:cNvGrpSpPr/>
          <p:nvPr/>
        </p:nvGrpSpPr>
        <p:grpSpPr>
          <a:xfrm>
            <a:off x="4325956" y="3429000"/>
            <a:ext cx="1549013" cy="2151756"/>
            <a:chOff x="3783031" y="3456028"/>
            <a:chExt cx="1549013" cy="2151756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E1E7A910-678E-C39C-485D-94C213FDF1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30506" t="23035" r="55028" b="63593"/>
            <a:stretch/>
          </p:blipFill>
          <p:spPr>
            <a:xfrm rot="5400000">
              <a:off x="4207887" y="4626891"/>
              <a:ext cx="1243405" cy="718381"/>
            </a:xfrm>
            <a:prstGeom prst="rect">
              <a:avLst/>
            </a:prstGeom>
          </p:spPr>
        </p:pic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304236BC-2ED1-4D45-DAE8-E3E6B23479D2}"/>
                </a:ext>
              </a:extLst>
            </p:cNvPr>
            <p:cNvGrpSpPr/>
            <p:nvPr/>
          </p:nvGrpSpPr>
          <p:grpSpPr>
            <a:xfrm>
              <a:off x="3783031" y="4414333"/>
              <a:ext cx="776453" cy="1177397"/>
              <a:chOff x="4950655" y="1489321"/>
              <a:chExt cx="776453" cy="1177397"/>
            </a:xfrm>
          </p:grpSpPr>
          <p:sp>
            <p:nvSpPr>
              <p:cNvPr id="37" name="Isosceles Triangle 36">
                <a:extLst>
                  <a:ext uri="{FF2B5EF4-FFF2-40B4-BE49-F238E27FC236}">
                    <a16:creationId xmlns:a16="http://schemas.microsoft.com/office/drawing/2014/main" id="{21C88E59-2C65-8A41-0263-B196D96A3526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5436506" y="1575264"/>
                <a:ext cx="56372" cy="88125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38" name="Isosceles Triangle 37">
                <a:extLst>
                  <a:ext uri="{FF2B5EF4-FFF2-40B4-BE49-F238E27FC236}">
                    <a16:creationId xmlns:a16="http://schemas.microsoft.com/office/drawing/2014/main" id="{F86D4CBC-31B3-07CD-4B44-DAF8FD9FE87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5436506" y="2037756"/>
                <a:ext cx="56372" cy="88125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39" name="Isosceles Triangle 38">
                <a:extLst>
                  <a:ext uri="{FF2B5EF4-FFF2-40B4-BE49-F238E27FC236}">
                    <a16:creationId xmlns:a16="http://schemas.microsoft.com/office/drawing/2014/main" id="{B99426B6-F9EE-B35B-6AB4-C4785D56B110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5436506" y="2394414"/>
                <a:ext cx="56372" cy="88125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4C0244D5-C6F3-806F-4272-8B10B3FC5D07}"/>
                  </a:ext>
                </a:extLst>
              </p:cNvPr>
              <p:cNvSpPr txBox="1"/>
              <p:nvPr/>
            </p:nvSpPr>
            <p:spPr>
              <a:xfrm>
                <a:off x="5153969" y="1489321"/>
                <a:ext cx="3241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4A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B623967-8025-CF3C-0F25-C63C6CA560B2}"/>
                  </a:ext>
                </a:extLst>
              </p:cNvPr>
              <p:cNvSpPr txBox="1"/>
              <p:nvPr/>
            </p:nvSpPr>
            <p:spPr>
              <a:xfrm>
                <a:off x="5153969" y="1951813"/>
                <a:ext cx="3241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/>
                  <a:t>7A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CDA7431-6C31-437F-D695-45EDF65D2FC5}"/>
                  </a:ext>
                </a:extLst>
              </p:cNvPr>
              <p:cNvSpPr txBox="1"/>
              <p:nvPr/>
            </p:nvSpPr>
            <p:spPr>
              <a:xfrm>
                <a:off x="4950655" y="2266608"/>
                <a:ext cx="77645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    7D </a:t>
                </a:r>
              </a:p>
              <a:p>
                <a:r>
                  <a:rPr lang="en-AU" sz="1000" dirty="0"/>
                  <a:t>(7D/7A)</a:t>
                </a:r>
              </a:p>
            </p:txBody>
          </p: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927FB89-2E7C-EB64-63F5-010B759D9612}"/>
                </a:ext>
              </a:extLst>
            </p:cNvPr>
            <p:cNvSpPr txBox="1"/>
            <p:nvPr/>
          </p:nvSpPr>
          <p:spPr>
            <a:xfrm rot="18706981">
              <a:off x="4243969" y="3976911"/>
              <a:ext cx="6639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/>
                <a:t>LDN 7D(7A)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E8C9B2F-AB6B-9CC8-C164-37EB7BE7839D}"/>
                </a:ext>
              </a:extLst>
            </p:cNvPr>
            <p:cNvSpPr txBox="1"/>
            <p:nvPr/>
          </p:nvSpPr>
          <p:spPr>
            <a:xfrm rot="18706981">
              <a:off x="4408354" y="4021735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/>
                <a:t>Langdon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36F27C3-97E7-6565-8C97-3E7CA1D58F55}"/>
                </a:ext>
              </a:extLst>
            </p:cNvPr>
            <p:cNvSpPr txBox="1"/>
            <p:nvPr/>
          </p:nvSpPr>
          <p:spPr>
            <a:xfrm rot="18706981">
              <a:off x="4517572" y="3945833"/>
              <a:ext cx="7473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/>
                <a:t>Cappelli </a:t>
              </a:r>
              <a:r>
                <a:rPr lang="en-AU" sz="800" i="1" dirty="0"/>
                <a:t>ph1c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E7120BC-2E09-F1EC-B9AF-249D02C8770A}"/>
                </a:ext>
              </a:extLst>
            </p:cNvPr>
            <p:cNvSpPr txBox="1"/>
            <p:nvPr/>
          </p:nvSpPr>
          <p:spPr>
            <a:xfrm rot="18706981">
              <a:off x="4709737" y="4071341"/>
              <a:ext cx="4106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/>
                <a:t>Bansi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331E422-2F61-EA2A-72D1-A36290AA7146}"/>
                </a:ext>
              </a:extLst>
            </p:cNvPr>
            <p:cNvSpPr txBox="1"/>
            <p:nvPr/>
          </p:nvSpPr>
          <p:spPr>
            <a:xfrm rot="18706981">
              <a:off x="4722421" y="3850207"/>
              <a:ext cx="10038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/>
                <a:t>Robin bread wheat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03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5</TotalTime>
  <Words>934</Words>
  <Application>Microsoft Office PowerPoint</Application>
  <PresentationFormat>Widescreen</PresentationFormat>
  <Paragraphs>7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Document</vt:lpstr>
      <vt:lpstr>PowerPoint Presentation</vt:lpstr>
      <vt:lpstr>PowerPoint Presentation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Hongyu (A&amp;F, Black Mountain)</dc:creator>
  <cp:lastModifiedBy>Ayliffe, Michael (A&amp;F, Black Mountain)</cp:lastModifiedBy>
  <cp:revision>107</cp:revision>
  <cp:lastPrinted>2022-11-17T03:43:12Z</cp:lastPrinted>
  <dcterms:created xsi:type="dcterms:W3CDTF">2019-05-10T03:33:24Z</dcterms:created>
  <dcterms:modified xsi:type="dcterms:W3CDTF">2023-08-01T07:16:54Z</dcterms:modified>
</cp:coreProperties>
</file>